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30" d="100"/>
          <a:sy n="130" d="100"/>
        </p:scale>
        <p:origin x="-72" y="-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7D036-055B-4C0E-9007-3ECD9B00529C}" type="datetimeFigureOut">
              <a:rPr lang="en-NZ" smtClean="0"/>
              <a:pPr/>
              <a:t>25/03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3E011-D0CE-4F6A-BD0E-73D74D7FD71D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323528" y="260648"/>
            <a:ext cx="8220005" cy="5215508"/>
            <a:chOff x="323528" y="260648"/>
            <a:chExt cx="8220005" cy="5215508"/>
          </a:xfrm>
        </p:grpSpPr>
        <p:pic>
          <p:nvPicPr>
            <p:cNvPr id="1026" name="Picture 2" descr="C:\Users\mdso006\Documents\Backup8032014\Paenibacillus genome\Dotplots\CEvsBr.tif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61999" y="332656"/>
              <a:ext cx="7620001" cy="5143500"/>
            </a:xfrm>
            <a:prstGeom prst="rect">
              <a:avLst/>
            </a:prstGeom>
            <a:noFill/>
          </p:spPr>
        </p:pic>
        <p:sp>
          <p:nvSpPr>
            <p:cNvPr id="7" name="TextBox 6"/>
            <p:cNvSpPr txBox="1"/>
            <p:nvPr/>
          </p:nvSpPr>
          <p:spPr>
            <a:xfrm>
              <a:off x="323528" y="260648"/>
              <a:ext cx="5040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dirty="0" smtClean="0"/>
                <a:t>(a)</a:t>
              </a:r>
              <a:endParaRPr lang="en-NZ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826617" y="404664"/>
              <a:ext cx="1980616" cy="31683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8" name="Rectangle 7"/>
            <p:cNvSpPr/>
            <p:nvPr/>
          </p:nvSpPr>
          <p:spPr>
            <a:xfrm rot="5400000">
              <a:off x="4681370" y="1663446"/>
              <a:ext cx="1898752" cy="56886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1492295" y="1782119"/>
              <a:ext cx="23042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100" i="1" dirty="0" smtClean="0"/>
                <a:t>P. darwinianus </a:t>
              </a:r>
              <a:r>
                <a:rPr lang="en-NZ" sz="1100" dirty="0" smtClean="0"/>
                <a:t>CE1 (Scaffolds 1-108) </a:t>
              </a:r>
              <a:endParaRPr lang="en-NZ" sz="11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292798" y="3675537"/>
              <a:ext cx="23042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100" i="1" dirty="0" smtClean="0"/>
                <a:t>P. darwinianus </a:t>
              </a:r>
              <a:r>
                <a:rPr lang="en-NZ" sz="1100" dirty="0" smtClean="0"/>
                <a:t>Br (Scaffolds 1-111) </a:t>
              </a:r>
              <a:endParaRPr lang="en-NZ" sz="11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640787" y="4093430"/>
              <a:ext cx="59027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800" smtClean="0"/>
                <a:t>Supplementary </a:t>
              </a:r>
              <a:r>
                <a:rPr lang="en-NZ" sz="800" smtClean="0"/>
                <a:t>figure 1</a:t>
              </a:r>
              <a:r>
                <a:rPr lang="en-NZ" sz="800" smtClean="0"/>
                <a:t>:  </a:t>
              </a:r>
              <a:r>
                <a:rPr lang="en-NZ" sz="800" dirty="0" err="1" smtClean="0"/>
                <a:t>Dotplot</a:t>
              </a:r>
              <a:r>
                <a:rPr lang="en-NZ" sz="800" dirty="0" smtClean="0"/>
                <a:t> diagrams comparing genomes of </a:t>
              </a:r>
              <a:r>
                <a:rPr lang="en-NZ" sz="800" i="1" dirty="0" smtClean="0"/>
                <a:t>P. darwinianus </a:t>
              </a:r>
              <a:r>
                <a:rPr lang="en-NZ" sz="800" dirty="0" smtClean="0"/>
                <a:t>strains  (a) Br and CE1, (b)  CE1 and MB1,  and (c)  Br and MB1. All </a:t>
              </a:r>
              <a:r>
                <a:rPr lang="en-NZ" sz="800" dirty="0" err="1" smtClean="0"/>
                <a:t>dotplot</a:t>
              </a:r>
              <a:r>
                <a:rPr lang="en-NZ" sz="800" dirty="0" smtClean="0"/>
                <a:t> diagram were generated on the IMG website.</a:t>
              </a:r>
              <a:endParaRPr lang="en-NZ" sz="800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323528" y="260648"/>
            <a:ext cx="8235259" cy="5626886"/>
            <a:chOff x="323528" y="260648"/>
            <a:chExt cx="8235259" cy="5626886"/>
          </a:xfrm>
        </p:grpSpPr>
        <p:pic>
          <p:nvPicPr>
            <p:cNvPr id="2050" name="Picture 2" descr="C:\Users\mdso006\Documents\Backup8032014\Paenibacillus genome\Dotplots\MBvsCE.tif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61999" y="620688"/>
              <a:ext cx="7620001" cy="5143500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323528" y="260648"/>
              <a:ext cx="5040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dirty="0" smtClean="0"/>
                <a:t>(b)</a:t>
              </a:r>
              <a:endParaRPr lang="en-NZ" dirty="0"/>
            </a:p>
          </p:txBody>
        </p:sp>
        <p:sp>
          <p:nvSpPr>
            <p:cNvPr id="4" name="Rectangle 3"/>
            <p:cNvSpPr/>
            <p:nvPr/>
          </p:nvSpPr>
          <p:spPr>
            <a:xfrm rot="10800000">
              <a:off x="744001" y="621791"/>
              <a:ext cx="2108638" cy="31875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1431337" y="2050340"/>
              <a:ext cx="23042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100" i="1" dirty="0" smtClean="0"/>
                <a:t>P. darwinianus </a:t>
              </a:r>
              <a:r>
                <a:rPr lang="en-NZ" sz="1100" dirty="0" smtClean="0"/>
                <a:t>MB1 (Scaffolds 1-107) </a:t>
              </a:r>
              <a:endParaRPr lang="en-NZ" sz="1100" dirty="0"/>
            </a:p>
          </p:txBody>
        </p:sp>
        <p:sp>
          <p:nvSpPr>
            <p:cNvPr id="7" name="Rectangle 6"/>
            <p:cNvSpPr/>
            <p:nvPr/>
          </p:nvSpPr>
          <p:spPr>
            <a:xfrm rot="16200000">
              <a:off x="4606885" y="1935632"/>
              <a:ext cx="2108638" cy="57951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242810" y="3830377"/>
              <a:ext cx="23042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100" i="1" dirty="0" smtClean="0"/>
                <a:t>P. darwinianus </a:t>
              </a:r>
              <a:r>
                <a:rPr lang="en-NZ" sz="1100" dirty="0" smtClean="0"/>
                <a:t>CE1 (Scaffolds 1-108) </a:t>
              </a:r>
              <a:endParaRPr lang="en-NZ" sz="1100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323528" y="260648"/>
            <a:ext cx="8205996" cy="5622634"/>
            <a:chOff x="323528" y="260648"/>
            <a:chExt cx="8205996" cy="5622634"/>
          </a:xfrm>
        </p:grpSpPr>
        <p:pic>
          <p:nvPicPr>
            <p:cNvPr id="3074" name="Picture 2" descr="C:\Users\mdso006\Documents\Backup8032014\Paenibacillus genome\Dotplots\MBvsBr.tif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61999" y="548680"/>
              <a:ext cx="7620001" cy="5143500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323528" y="260648"/>
              <a:ext cx="5040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mtClean="0"/>
                <a:t>(c)</a:t>
              </a:r>
              <a:endParaRPr lang="en-NZ" dirty="0"/>
            </a:p>
          </p:txBody>
        </p:sp>
        <p:sp>
          <p:nvSpPr>
            <p:cNvPr id="5" name="Rectangle 4"/>
            <p:cNvSpPr/>
            <p:nvPr/>
          </p:nvSpPr>
          <p:spPr>
            <a:xfrm rot="5400000">
              <a:off x="4622277" y="1976035"/>
              <a:ext cx="2108638" cy="570585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6" name="Rectangle 5"/>
            <p:cNvSpPr/>
            <p:nvPr/>
          </p:nvSpPr>
          <p:spPr>
            <a:xfrm rot="10800000">
              <a:off x="744001" y="577901"/>
              <a:ext cx="2108638" cy="31875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NZ"/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1431337" y="1911355"/>
              <a:ext cx="23042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100" i="1" dirty="0" smtClean="0"/>
                <a:t>P. darwinianus </a:t>
              </a:r>
              <a:r>
                <a:rPr lang="en-NZ" sz="1100" dirty="0" smtClean="0"/>
                <a:t>MB1 (Scaffolds 1-107) </a:t>
              </a:r>
              <a:endParaRPr lang="en-NZ" sz="11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572000" y="3858417"/>
              <a:ext cx="23042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NZ" sz="1100" i="1" dirty="0" smtClean="0"/>
                <a:t>P. darwinianus </a:t>
              </a:r>
              <a:r>
                <a:rPr lang="en-NZ" sz="1100" dirty="0" smtClean="0"/>
                <a:t>Br (Scaffolds 1-111) </a:t>
              </a:r>
              <a:endParaRPr lang="en-NZ" sz="11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02</Words>
  <Application>Microsoft Office PowerPoint</Application>
  <PresentationFormat>On-screen Show (4:3)</PresentationFormat>
  <Paragraphs>10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Uo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dso006</dc:creator>
  <cp:lastModifiedBy>mdso006</cp:lastModifiedBy>
  <cp:revision>5</cp:revision>
  <dcterms:created xsi:type="dcterms:W3CDTF">2014-03-11T08:37:41Z</dcterms:created>
  <dcterms:modified xsi:type="dcterms:W3CDTF">2014-03-25T05:26:15Z</dcterms:modified>
</cp:coreProperties>
</file>